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4" autoAdjust="0"/>
    <p:restoredTop sz="94660"/>
  </p:normalViewPr>
  <p:slideViewPr>
    <p:cSldViewPr snapToGrid="0">
      <p:cViewPr varScale="1">
        <p:scale>
          <a:sx n="89" d="100"/>
          <a:sy n="89" d="100"/>
        </p:scale>
        <p:origin x="65" y="7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cello Otake Sato" userId="f860b592-28d6-473e-9f4b-e165cc1e8e58" providerId="ADAL" clId="{AC1D696E-80D6-4C69-AEE2-C818E2AF2707}"/>
    <pc:docChg chg="modSld">
      <pc:chgData name="Marcello Otake Sato" userId="f860b592-28d6-473e-9f4b-e165cc1e8e58" providerId="ADAL" clId="{AC1D696E-80D6-4C69-AEE2-C818E2AF2707}" dt="2025-07-29T07:23:11.691" v="2" actId="6549"/>
      <pc:docMkLst>
        <pc:docMk/>
      </pc:docMkLst>
      <pc:sldChg chg="modSp mod">
        <pc:chgData name="Marcello Otake Sato" userId="f860b592-28d6-473e-9f4b-e165cc1e8e58" providerId="ADAL" clId="{AC1D696E-80D6-4C69-AEE2-C818E2AF2707}" dt="2025-07-29T07:23:11.691" v="2" actId="6549"/>
        <pc:sldMkLst>
          <pc:docMk/>
          <pc:sldMk cId="3418716871" sldId="256"/>
        </pc:sldMkLst>
        <pc:spChg chg="mod">
          <ac:chgData name="Marcello Otake Sato" userId="f860b592-28d6-473e-9f4b-e165cc1e8e58" providerId="ADAL" clId="{AC1D696E-80D6-4C69-AEE2-C818E2AF2707}" dt="2025-07-29T07:23:11.691" v="2" actId="6549"/>
          <ac:spMkLst>
            <pc:docMk/>
            <pc:sldMk cId="3418716871" sldId="256"/>
            <ac:spMk id="5" creationId="{9DBBB1D5-3B56-C89C-DA89-71E2BA9D80C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116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856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18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849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785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774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435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616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266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84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937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3F3DE68-EA97-4427-8811-A39431467FD0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15CDE4-4D78-4F94-8254-48AAA79C35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946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DBBB1D5-3B56-C89C-DA89-71E2BA9D80C4}"/>
              </a:ext>
            </a:extLst>
          </p:cNvPr>
          <p:cNvSpPr txBox="1"/>
          <p:nvPr/>
        </p:nvSpPr>
        <p:spPr>
          <a:xfrm>
            <a:off x="1301960" y="3917015"/>
            <a:ext cx="6752026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Supplemental Figure 2. Comparison of edaphic factors between eDNA-positive and eDNA-negative sites using Wilcoxon two-sample/Mann-Whitney U test. Figure A (on the left) shows the comparison of </a:t>
            </a:r>
            <a:r>
              <a:rPr lang="en-US" sz="1100" i="1" dirty="0"/>
              <a:t>O. h. </a:t>
            </a:r>
            <a:r>
              <a:rPr lang="en-US" sz="1100" i="1" dirty="0" err="1"/>
              <a:t>quadrasi</a:t>
            </a:r>
            <a:r>
              <a:rPr lang="en-US" sz="1100" dirty="0"/>
              <a:t> and </a:t>
            </a:r>
            <a:r>
              <a:rPr lang="en-US" sz="1100" i="1" dirty="0"/>
              <a:t>S. japonicum</a:t>
            </a:r>
            <a:r>
              <a:rPr lang="en-US" sz="1100" dirty="0"/>
              <a:t> multiplex qPCR results and soil pH, with significantly higher pH values in eDNA-positive sites (p &lt; 0.05*). B (center) and C (on the right) show the comparison of </a:t>
            </a:r>
            <a:r>
              <a:rPr lang="en-US" sz="1100" i="1" dirty="0"/>
              <a:t>O. h. </a:t>
            </a:r>
            <a:r>
              <a:rPr lang="en-US" sz="1100" i="1" dirty="0" err="1"/>
              <a:t>quadrasi</a:t>
            </a:r>
            <a:r>
              <a:rPr lang="en-US" sz="1100" dirty="0"/>
              <a:t> and </a:t>
            </a:r>
            <a:r>
              <a:rPr lang="en-US" sz="1100" i="1" dirty="0"/>
              <a:t>S. japonicum</a:t>
            </a:r>
            <a:r>
              <a:rPr lang="en-US" sz="1100" dirty="0"/>
              <a:t> multiplex qPCR results with soil moisture (%), and temperature (</a:t>
            </a:r>
            <a:r>
              <a:rPr lang="en-US" sz="1100" baseline="30000" dirty="0" err="1"/>
              <a:t>o</a:t>
            </a:r>
            <a:r>
              <a:rPr lang="en-US" sz="1100" dirty="0" err="1"/>
              <a:t>C</a:t>
            </a:r>
            <a:r>
              <a:rPr lang="en-US" sz="1100" dirty="0"/>
              <a:t>) respectively. No statistically significant differences were observed in B (p=0.51) and C (p=0.07).</a:t>
            </a:r>
          </a:p>
        </p:txBody>
      </p:sp>
      <p:pic>
        <p:nvPicPr>
          <p:cNvPr id="7" name="Picture 6" descr="A screenshot of a computer&#10;&#10;AI-generated content may be incorrect.">
            <a:extLst>
              <a:ext uri="{FF2B5EF4-FFF2-40B4-BE49-F238E27FC236}">
                <a16:creationId xmlns:a16="http://schemas.microsoft.com/office/drawing/2014/main" id="{097A440D-87E0-0E58-F826-E2AFF5889C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78124"/>
            <a:ext cx="9144000" cy="21763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8716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1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cello Otake Sato</dc:creator>
  <cp:lastModifiedBy>Marcello Otake Sato</cp:lastModifiedBy>
  <cp:revision>1</cp:revision>
  <dcterms:created xsi:type="dcterms:W3CDTF">2025-06-05T02:14:23Z</dcterms:created>
  <dcterms:modified xsi:type="dcterms:W3CDTF">2025-07-29T07:23:50Z</dcterms:modified>
</cp:coreProperties>
</file>